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0" d="100"/>
          <a:sy n="120" d="100"/>
        </p:scale>
        <p:origin x="258" y="-3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205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20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813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947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226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108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623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510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39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506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365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CB0AB-B176-4212-910F-0005A93EE85F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54A0D6-8BE9-4EB8-9B9E-A512C570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363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>
            <a:off x="678279" y="6494208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CD10</a:t>
            </a:r>
            <a:endParaRPr lang="en-US" sz="1400" dirty="0"/>
          </a:p>
        </p:txBody>
      </p:sp>
      <p:grpSp>
        <p:nvGrpSpPr>
          <p:cNvPr id="55" name="Group 54"/>
          <p:cNvGrpSpPr/>
          <p:nvPr/>
        </p:nvGrpSpPr>
        <p:grpSpPr>
          <a:xfrm>
            <a:off x="314288" y="0"/>
            <a:ext cx="7761734" cy="6534150"/>
            <a:chOff x="493398" y="0"/>
            <a:chExt cx="7761734" cy="6534150"/>
          </a:xfrm>
        </p:grpSpPr>
        <p:pic>
          <p:nvPicPr>
            <p:cNvPr id="1026" name="Picture 2" descr="C:\Users\Malkie\Desktop\60D_ancestry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72" t="3966" r="43314" b="54646"/>
            <a:stretch/>
          </p:blipFill>
          <p:spPr bwMode="auto">
            <a:xfrm>
              <a:off x="4019534" y="1654272"/>
              <a:ext cx="2838450" cy="31813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2" descr="C:\Users\Malkie\Desktop\60D_ancestry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835" t="44609" r="23256" b="42173"/>
            <a:stretch/>
          </p:blipFill>
          <p:spPr bwMode="auto">
            <a:xfrm>
              <a:off x="731062" y="2743200"/>
              <a:ext cx="1239158" cy="1016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2" descr="C:\Users\Malkie\Desktop\60D_ancestry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54" t="15366" r="22868" b="69269"/>
            <a:stretch/>
          </p:blipFill>
          <p:spPr bwMode="auto">
            <a:xfrm>
              <a:off x="684564" y="0"/>
              <a:ext cx="1302658" cy="1181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2" descr="C:\Users\Malkie\Desktop\60D_ancestry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54" t="30732" r="22868" b="55720"/>
            <a:stretch/>
          </p:blipFill>
          <p:spPr bwMode="auto">
            <a:xfrm>
              <a:off x="684564" y="1447800"/>
              <a:ext cx="1302658" cy="1041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" descr="C:\Users\Malkie\Desktop\60D_ancestry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54" t="71541" r="25304" b="14829"/>
            <a:stretch/>
          </p:blipFill>
          <p:spPr bwMode="auto">
            <a:xfrm>
              <a:off x="690653" y="5486400"/>
              <a:ext cx="1143000" cy="10477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 rot="16200000">
              <a:off x="218369" y="1789407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SSC</a:t>
              </a:r>
              <a:endParaRPr lang="en-US" sz="14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190087" y="3066541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SSC</a:t>
              </a:r>
              <a:endParaRPr lang="en-US" sz="14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869351" y="1143000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FSC</a:t>
              </a:r>
              <a:endParaRPr 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78778" y="2438400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FSC</a:t>
              </a:r>
              <a:endParaRPr lang="en-US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78778" y="3717406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CD3</a:t>
              </a:r>
              <a:endParaRPr lang="en-US" sz="14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69351" y="5071330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CD19</a:t>
              </a:r>
              <a:endParaRPr lang="en-US" sz="1400" dirty="0"/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699312" y="4067628"/>
              <a:ext cx="1302658" cy="1079500"/>
              <a:chOff x="419100" y="4038600"/>
              <a:chExt cx="1302658" cy="1079500"/>
            </a:xfrm>
          </p:grpSpPr>
          <p:pic>
            <p:nvPicPr>
              <p:cNvPr id="9" name="Picture 2" descr="C:\Users\Malkie\Desktop\60D_ancestry.jpg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254" t="57745" r="22868" b="28211"/>
              <a:stretch/>
            </p:blipFill>
            <p:spPr bwMode="auto">
              <a:xfrm>
                <a:off x="419100" y="4038600"/>
                <a:ext cx="1302658" cy="10795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8" name="Straight Connector 17"/>
              <p:cNvCxnSpPr/>
              <p:nvPr/>
            </p:nvCxnSpPr>
            <p:spPr>
              <a:xfrm>
                <a:off x="533400" y="5105400"/>
                <a:ext cx="552450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/>
            <p:cNvSpPr txBox="1"/>
            <p:nvPr/>
          </p:nvSpPr>
          <p:spPr>
            <a:xfrm rot="16200000">
              <a:off x="232510" y="5818777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SSC</a:t>
              </a:r>
              <a:endParaRPr lang="en-US" sz="14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134473" y="4835622"/>
              <a:ext cx="914400" cy="381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CD21</a:t>
              </a:r>
              <a:endParaRPr lang="en-US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3412914" y="3145661"/>
              <a:ext cx="914400" cy="381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CD27</a:t>
              </a:r>
              <a:endParaRPr lang="en-US" dirty="0"/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>
              <a:off x="4019534" y="2489200"/>
              <a:ext cx="599600" cy="23446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2662668" y="2096869"/>
              <a:ext cx="12954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a</a:t>
              </a:r>
              <a:r>
                <a:rPr lang="en-US" dirty="0" smtClean="0"/>
                <a:t>ctivated </a:t>
              </a:r>
            </a:p>
            <a:p>
              <a:pPr algn="ctr"/>
              <a:r>
                <a:rPr lang="en-US" dirty="0" smtClean="0"/>
                <a:t>memory</a:t>
              </a:r>
              <a:endParaRPr lang="en-US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959732" y="2120837"/>
              <a:ext cx="12954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classical</a:t>
              </a:r>
            </a:p>
            <a:p>
              <a:pPr algn="ctr"/>
              <a:r>
                <a:rPr lang="en-US" dirty="0" smtClean="0"/>
                <a:t>memory</a:t>
              </a:r>
              <a:endParaRPr lang="en-US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919450" y="3974372"/>
              <a:ext cx="1295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err="1" smtClean="0"/>
                <a:t>na</a:t>
              </a:r>
              <a:r>
                <a:rPr lang="el-GR" dirty="0" smtClean="0">
                  <a:latin typeface="Calibri"/>
                </a:rPr>
                <a:t>ϊ</a:t>
              </a:r>
              <a:r>
                <a:rPr lang="en-US" dirty="0" err="1" smtClean="0">
                  <a:latin typeface="Calibri"/>
                </a:rPr>
                <a:t>ve</a:t>
              </a:r>
              <a:endParaRPr lang="en-US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662668" y="3811905"/>
              <a:ext cx="12954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atypical</a:t>
              </a:r>
            </a:p>
            <a:p>
              <a:pPr algn="ctr"/>
              <a:r>
                <a:rPr lang="en-US" dirty="0" smtClean="0"/>
                <a:t>memory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204228" y="4419839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SSC</a:t>
              </a:r>
              <a:endParaRPr lang="en-US" sz="14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173101" y="2734048"/>
              <a:ext cx="8381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12.2%</a:t>
              </a:r>
              <a:endParaRPr lang="en-US" sz="11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170150" y="4082094"/>
              <a:ext cx="8381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14.3%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166166" y="5475983"/>
              <a:ext cx="8381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97.1%</a:t>
              </a: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1248229" y="203200"/>
              <a:ext cx="188685" cy="725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Rectangle 55"/>
            <p:cNvSpPr/>
            <p:nvPr/>
          </p:nvSpPr>
          <p:spPr>
            <a:xfrm>
              <a:off x="1226458" y="1574800"/>
              <a:ext cx="188685" cy="725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Rectangle 56"/>
            <p:cNvSpPr/>
            <p:nvPr/>
          </p:nvSpPr>
          <p:spPr>
            <a:xfrm>
              <a:off x="907143" y="3127829"/>
              <a:ext cx="197757" cy="1297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1596572" y="4524376"/>
              <a:ext cx="165553" cy="1201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1030515" y="5994400"/>
              <a:ext cx="188685" cy="725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154253" y="1459666"/>
              <a:ext cx="8381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35.7%</a:t>
              </a:r>
              <a:endParaRPr lang="en-US" sz="11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154158" y="142659"/>
              <a:ext cx="8381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82.2%</a:t>
              </a:r>
              <a:endParaRPr lang="en-US" sz="11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246649" y="455711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DAPI</a:t>
              </a:r>
              <a:endParaRPr lang="en-US" sz="1400" dirty="0"/>
            </a:p>
          </p:txBody>
        </p:sp>
      </p:grpSp>
      <p:cxnSp>
        <p:nvCxnSpPr>
          <p:cNvPr id="60" name="Straight Arrow Connector 59"/>
          <p:cNvCxnSpPr/>
          <p:nvPr/>
        </p:nvCxnSpPr>
        <p:spPr>
          <a:xfrm flipV="1">
            <a:off x="3853293" y="3793361"/>
            <a:ext cx="586731" cy="23209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>
            <a:stCxn id="44" idx="1"/>
          </p:cNvCxnSpPr>
          <p:nvPr/>
        </p:nvCxnSpPr>
        <p:spPr>
          <a:xfrm flipH="1">
            <a:off x="6171706" y="2444003"/>
            <a:ext cx="608916" cy="29919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 flipH="1" flipV="1">
            <a:off x="6071942" y="3806264"/>
            <a:ext cx="708680" cy="21558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11167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31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herine Manix</dc:creator>
  <cp:lastModifiedBy>johanna daily</cp:lastModifiedBy>
  <cp:revision>9</cp:revision>
  <dcterms:created xsi:type="dcterms:W3CDTF">2015-02-09T21:20:52Z</dcterms:created>
  <dcterms:modified xsi:type="dcterms:W3CDTF">2015-02-23T15:38:38Z</dcterms:modified>
</cp:coreProperties>
</file>